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83945-738F-1078-65FE-F83C6D599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F99A9C-8B28-C9A5-2316-CFC9D85F7D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2FEF1F-9586-A4EC-52A9-1CCE52D9E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4A1D83-58E0-D95D-4680-75FB01A69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B67CC4-DBD6-2BC8-C2C7-138E969A2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623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0EA0D-D601-8E13-C41F-FAA805776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5979BD-6C05-267C-5181-DD8E628042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F2020-A3B7-02CA-2453-3BAEDA31E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1C4CE1-0006-DE8D-5677-E711A1821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3DA18A-EBC0-ACCB-6ACB-4C1FF06EA2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475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69FA4E-BCC2-4357-7FCE-791736F35D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2DBB6F-D997-847D-0721-9923C2D61B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5DB864-5FFB-6C66-7425-0CA8DDE9A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26FD0-D5F8-C41C-8F43-B72800778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CFA902-C474-D642-AFBF-69D1BEA89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848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54C38-8186-BC81-D2CE-18D19AEFFF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C8E68D-0F97-9360-BB44-009FD93B08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FC5E63-8CE3-7363-1579-23C85C05F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32CE15-850A-DEC0-61A7-FF9D5E154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C7123A-DC94-8EF8-093D-241CBF75A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735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BE465-BD70-0305-626E-2DDE27783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DC6420-9854-35EE-6664-30E588D9BB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1E4EB-0D55-BE13-82DA-C7F470D1A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B1D00-4E36-B3F1-36B8-04B64AFD4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14285F-B5A1-2ABB-F9BB-4A6DD98CE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548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3FA6C-F167-F350-6CDC-BAC32E8DE6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F6C802-43A3-138A-62CE-18EE3F679A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D477CE-93AF-7CB9-3F57-2BFDF41695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27C9B6-6DF2-823D-4278-919D21B5E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3C0C32-E13A-09EA-66F7-E668CF149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DFD02D-F4CC-C6F2-A644-89B293D4E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687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3B7525-5EA7-35D3-5E02-6D558E62F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FA8560-4AA2-A18B-FF4D-A93C4A79F5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73AC98-FFC7-5AA9-96C0-A18B0AE547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67706F-7506-F7D3-49FB-28E48766A4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FCC47-3BD9-BD15-9F96-535F943346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75DD9B-C5DB-C80C-A637-CF6329119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929608-F748-D634-CD9E-944203C79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CD391D-0955-9EE8-FCEC-8757E9F2D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66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CEFCF-6C75-F679-D953-4E8B8C68AE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B98133-0117-7FC5-70A4-772FAEBF1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D7EA77-03F3-A194-8316-52931A4D7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C8B6B3-C16B-D0DD-6245-AACE16774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323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AA658E-C8EB-DF8E-BFCC-62F48AEDF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0CD829-3433-D90D-7607-567006A60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59BF71-5E09-8507-9195-AF12CD6FA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148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100F6-FE45-AD1E-819E-2A2E1AA34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6D43F1-C8AA-429F-57D8-68970C4526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E3B0D-7AFD-D602-2D21-6E516494A4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7AFBBD-1BDE-75EB-EDBE-843114697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8160F3-1B78-64CD-49B8-B356A3A74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2C1C6C-01F1-0E45-209D-BEC7605DD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450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C25F5-4AE1-A411-9629-838566ACB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934DF7-927F-BBF5-DBE7-656E93AEA2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BCE1CE-2D05-AE9F-624D-7AD6A3A6E4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C878B1-2397-D213-248F-A2F4BA945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054B07-71C5-AE3B-E2D9-789F26CBA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E5ECB5-CC15-A550-C5E1-94E3D87B1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147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62F3EC-CAFB-3009-203F-15D7E9519C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C2F010-A7DB-2713-1498-67AC9635C0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9C0C02-E77F-96C3-F9D4-BF3BD8817B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8A52F-00E4-124D-83EE-B556B920038C}" type="datetimeFigureOut">
              <a:rPr lang="en-US" smtClean="0"/>
              <a:t>10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A076A-AACE-07B4-DF2A-0C535EF21D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D2F893-F0A5-B3D1-3775-471112FFC5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EAF4C-E68F-DA47-9DF2-4BE0B4D0A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853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B2AB667-590E-2014-0F71-C6FE6B3A5CA5}"/>
              </a:ext>
            </a:extLst>
          </p:cNvPr>
          <p:cNvSpPr txBox="1"/>
          <p:nvPr/>
        </p:nvSpPr>
        <p:spPr>
          <a:xfrm>
            <a:off x="3048000" y="324696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Fingerstick glucose				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IGH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6233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x-ray of a person's chest&#10;&#10;Description automatically generated">
            <a:extLst>
              <a:ext uri="{FF2B5EF4-FFF2-40B4-BE49-F238E27FC236}">
                <a16:creationId xmlns:a16="http://schemas.microsoft.com/office/drawing/2014/main" id="{2FD24E7E-C9D0-F797-FC40-D420ED89EE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9162" y="0"/>
            <a:ext cx="8093675" cy="68675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3293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heart rate&#10;&#10;Description automatically generated">
            <a:extLst>
              <a:ext uri="{FF2B5EF4-FFF2-40B4-BE49-F238E27FC236}">
                <a16:creationId xmlns:a16="http://schemas.microsoft.com/office/drawing/2014/main" id="{B432870C-A55C-CAA4-D52D-E9FC31D0CEC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4778"/>
            <a:ext cx="12225685" cy="6388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7765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895DB21-BFAA-624A-0BF3-144F509A48CE}"/>
              </a:ext>
            </a:extLst>
          </p:cNvPr>
          <p:cNvSpPr txBox="1"/>
          <p:nvPr/>
        </p:nvSpPr>
        <p:spPr>
          <a:xfrm>
            <a:off x="3049030" y="1997839"/>
            <a:ext cx="6098058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asic metabolic panel (BMP)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odium				128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tassium				6.7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hloride				90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icarbonate (HC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	3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lood Urea Nitrogen (BUN)		34 mg/d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reatinine (Cr)				2.38 mg/d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Glucose				&gt;960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alcium				10.9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nion Gap				35.00 mmol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090374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79E3DA3-BE1B-35C6-EDF0-7392375954D6}"/>
              </a:ext>
            </a:extLst>
          </p:cNvPr>
          <p:cNvSpPr txBox="1"/>
          <p:nvPr/>
        </p:nvSpPr>
        <p:spPr>
          <a:xfrm>
            <a:off x="3048000" y="2277465"/>
            <a:ext cx="6096000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lete blood count (CBC)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White blood count (WBC)		39.2 x 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oglobin (Hgb)				17.1 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atocrit (HCT)				56.3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atelet (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t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	302 x 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RBC Count				6.77 x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Neutrophils				86.0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ymphocytes				6.0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637827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C2899E-7F94-29C0-A0BC-3D920172CDAD}"/>
              </a:ext>
            </a:extLst>
          </p:cNvPr>
          <p:cNvSpPr txBox="1"/>
          <p:nvPr/>
        </p:nvSpPr>
        <p:spPr>
          <a:xfrm>
            <a:off x="3048000" y="2000466"/>
            <a:ext cx="609600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Venous blood gas (VBG)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						6.83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CO2						20 mmHg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2						37 mmHg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CO3						3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Venous O2 Sat				36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s-E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67915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1F5C0E0-D60D-DA86-6F76-8956C51D3E91}"/>
              </a:ext>
            </a:extLst>
          </p:cNvPr>
          <p:cNvSpPr txBox="1"/>
          <p:nvPr/>
        </p:nvSpPr>
        <p:spPr>
          <a:xfrm>
            <a:off x="3048000" y="324696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s-ES" sz="1800" i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eta-</a:t>
            </a:r>
            <a:r>
              <a:rPr lang="es-ES" sz="1800" i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Hydroxybutyrate</a:t>
            </a:r>
            <a:r>
              <a:rPr lang="es-E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			</a:t>
            </a:r>
            <a:r>
              <a:rPr lang="es-E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&gt;13.5 mmol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094820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1</Words>
  <Application>Microsoft Macintosh PowerPoint</Application>
  <PresentationFormat>Widescreen</PresentationFormat>
  <Paragraphs>2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ohey, Shannon</dc:creator>
  <cp:lastModifiedBy>Toohey, Shannon</cp:lastModifiedBy>
  <cp:revision>1</cp:revision>
  <dcterms:created xsi:type="dcterms:W3CDTF">2023-10-31T03:28:27Z</dcterms:created>
  <dcterms:modified xsi:type="dcterms:W3CDTF">2023-10-31T03:30:27Z</dcterms:modified>
</cp:coreProperties>
</file>